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57" d="100"/>
          <a:sy n="157" d="100"/>
        </p:scale>
        <p:origin x="-178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ED560F-950A-4F28-B738-E1F2D54E4AFA}" type="datetimeFigureOut">
              <a:rPr lang="en-US" smtClean="0"/>
              <a:t>12/2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53E23C-43B6-4620-ADE2-BF459ADAA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8493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53E23C-43B6-4620-ADE2-BF459ADAAED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0209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885E3CB-DA53-452C-9FC1-24F00781E11B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0374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\\hn1\lwei\Work\WL_papers\2015_02_Special_collection\2015_11_v2.49_submitted_to_Genome_Medicine\Figure_S1_v2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0" y="762000"/>
            <a:ext cx="7110295" cy="53324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/>
          <p:cNvSpPr/>
          <p:nvPr/>
        </p:nvSpPr>
        <p:spPr>
          <a:xfrm>
            <a:off x="0" y="0"/>
            <a:ext cx="9144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An example of previous observation of neoplasm contamination in adjacent non-neoplastic tissues. </a:t>
            </a:r>
          </a:p>
        </p:txBody>
      </p:sp>
    </p:spTree>
    <p:extLst>
      <p:ext uri="{BB962C8B-B14F-4D97-AF65-F5344CB8AC3E}">
        <p14:creationId xmlns:p14="http://schemas.microsoft.com/office/powerpoint/2010/main" val="28268642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\\hn1\lwei\Work\WL_papers\2015_02_Special_collection\2015_11_v2.49_submitted_to_Genome_Medicine\Figure_S2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0913" y="981075"/>
            <a:ext cx="7242175" cy="48942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1514" y="0"/>
            <a:ext cx="914551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An example of one somatic mutation (BRCA2 S3041*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resen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the matched normal data from adjacent non-neoplastic tissue. </a:t>
            </a:r>
          </a:p>
        </p:txBody>
      </p:sp>
    </p:spTree>
    <p:extLst>
      <p:ext uri="{BB962C8B-B14F-4D97-AF65-F5344CB8AC3E}">
        <p14:creationId xmlns:p14="http://schemas.microsoft.com/office/powerpoint/2010/main" val="12662485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\\hn1\lwei\Work\WL_papers\2015_02_Special_collection\2015_11_v2.49_submitted_to_Genome_Medicine\Figure_S3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9288"/>
            <a:ext cx="9144000" cy="5559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1514" y="0"/>
            <a:ext cx="914551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: Coverage by targeted capture sequencing (TA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0" y="609600"/>
            <a:ext cx="109677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verage (X)</a:t>
            </a:r>
          </a:p>
        </p:txBody>
      </p:sp>
      <p:sp>
        <p:nvSpPr>
          <p:cNvPr id="6" name="Rectangle 5"/>
          <p:cNvSpPr/>
          <p:nvPr/>
        </p:nvSpPr>
        <p:spPr>
          <a:xfrm>
            <a:off x="3739126" y="6172200"/>
            <a:ext cx="83388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NV IDs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0" y="6581001"/>
            <a:ext cx="9144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SNV IDs format is dot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minate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including the following fields in hg19: 1)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2)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siitio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3) reference allele; 4) mutant allel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563678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E:\Work\WL_papers\2015_02_Special_collection\EVNC_figure5_VAF_WESvsTAS_font25.mod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719548"/>
            <a:ext cx="9144000" cy="50716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0" y="6913"/>
            <a:ext cx="9144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: Concordance of variant allele fraction (VAF) between whole-exome sequencing (WES) and targeted capture sequencing (TAS)</a:t>
            </a:r>
          </a:p>
        </p:txBody>
      </p:sp>
    </p:spTree>
    <p:extLst>
      <p:ext uri="{BB962C8B-B14F-4D97-AF65-F5344CB8AC3E}">
        <p14:creationId xmlns:p14="http://schemas.microsoft.com/office/powerpoint/2010/main" val="31098893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18</Words>
  <Application>Microsoft Office PowerPoint</Application>
  <PresentationFormat>On-screen Show (4:3)</PresentationFormat>
  <Paragraphs>9</Paragraphs>
  <Slides>4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ffice</dc:creator>
  <cp:lastModifiedBy>Lei Wei</cp:lastModifiedBy>
  <cp:revision>5</cp:revision>
  <dcterms:created xsi:type="dcterms:W3CDTF">2006-08-16T00:00:00Z</dcterms:created>
  <dcterms:modified xsi:type="dcterms:W3CDTF">2015-12-21T19:31:57Z</dcterms:modified>
</cp:coreProperties>
</file>